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102475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D3B235-B568-4E36-AD80-A5F49BB20EE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647282-F203-4AE3-8095-6E7682D980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D0C060-55A0-4FBB-8D2A-E8C52D30A2A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DEDEEA-D3C5-4A52-A349-14D66A4A0B9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85D24D-0537-4E6F-A95D-07D482A5C2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FF2C30-A931-4DFE-A3A0-53F9A46ED91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CD0CD7-6668-4A44-AA57-EFBB92C2B7A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9B535B-8A88-4F7B-BF7B-75852ECC114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8C85EA-AE73-46D7-89D1-84C2D4CDFE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544686-66ED-455F-B554-ED6FCBF03D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BCD12A-5450-4342-AAC4-F1452FA244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33963C-5774-44C0-BE53-4F97368AA0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A5C9AB1-4244-4A19-84C8-4798939A2924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611280" y="1916280"/>
          <a:ext cx="8281800" cy="2895480"/>
        </p:xfrm>
        <a:graphic>
          <a:graphicData uri="http://schemas.openxmlformats.org/drawingml/2006/table">
            <a:tbl>
              <a:tblPr/>
              <a:tblGrid>
                <a:gridCol w="957240"/>
                <a:gridCol w="2290680"/>
                <a:gridCol w="1623960"/>
                <a:gridCol w="1460520"/>
                <a:gridCol w="1949400"/>
              </a:tblGrid>
              <a:tr h="579240"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nnotat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www.ncbi.nlm.nih.gov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ene I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www.silkdb.org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olecular weigh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ranscription chang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79600"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and 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uticular protein glycine-rich 25 precursor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162.6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o significant chang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77800">
                <a:tc rowSpan="3"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and 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uticular protein RR-1 motif 4 precursor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GIBMGA002548-T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846.1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Ⅳ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M:3 h&gt;IV-3:12 h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792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uticular protein RR-1 motif 46 precursor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GIBMGA000324-T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285.5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V-3:12 h&gt;Ⅳ-M:3 h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796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uticular protein RR-2 motif 70 precursor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GIBMGA010143-T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938.0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V-3:12 h&gt;Ⅳ-M:3 h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42" name="文本框 2"/>
          <p:cNvSpPr/>
          <p:nvPr/>
        </p:nvSpPr>
        <p:spPr>
          <a:xfrm>
            <a:off x="-5400" y="7920"/>
            <a:ext cx="1093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Table S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67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YBSIBS</dc:creator>
  <dc:description/>
  <dc:language>en-US</dc:language>
  <cp:lastModifiedBy>BingYang</cp:lastModifiedBy>
  <dcterms:modified xsi:type="dcterms:W3CDTF">2016-07-08T06:18:58Z</dcterms:modified>
  <cp:revision>1096</cp:revision>
  <dc:subject/>
  <dc:title>Work report</dc:title>
</cp:coreProperties>
</file>